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0.bin" ContentType="application/vnd.openxmlformats-officedocument.oleObject"/>
  <Override PartName="/ppt/embeddings/oleObject7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9.bin" ContentType="application/vnd.openxmlformats-officedocument.oleObject"/>
  <Override PartName="/ppt/embeddings/oleObject5.bin" ContentType="application/vnd.openxmlformats-officedocument.oleObject"/>
  <Override PartName="/ppt/embeddings/oleObject18.bin" ContentType="application/vnd.openxmlformats-officedocument.oleObject"/>
  <Override PartName="/ppt/embeddings/oleObject20.bin" ContentType="application/vnd.openxmlformats-officedocument.oleObject"/>
  <Override PartName="/ppt/embeddings/oleObject4.bin" ContentType="application/vnd.openxmlformats-officedocument.oleObject"/>
  <Override PartName="/ppt/embeddings/oleObject6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7A0E6-DDE9-42D6-9288-89B46C4CED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5891E-3BBD-46BA-95CD-72951FE649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E984C-B9F4-41A9-822C-BFB9063A23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77FC1-962D-4267-A849-33B932D1E0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B9061-2C7F-467E-8F7A-7A66C10258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75795-DC2D-4B80-BE97-8640527886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8BA1E-D331-40D9-82C6-53CEAF2F5A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BFA99-CC17-4970-B499-251BB0246C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2E8B5-B172-48FF-A827-3B6286C6B6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F575D-63CC-410C-8B20-8827615A6E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5F184-8785-461E-A191-50E64C7F55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4E39C-925E-4EC0-8ABF-C03FA8873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8A310C-DBA3-47A1-96FA-F9A795F5C0B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3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14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15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6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7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18.png"/><Relationship Id="rId37" Type="http://schemas.openxmlformats.org/officeDocument/2006/relationships/oleObject" Target="../embeddings/oleObject19.bin"/><Relationship Id="rId38" Type="http://schemas.openxmlformats.org/officeDocument/2006/relationships/image" Target="../media/image19.png"/><Relationship Id="rId39" Type="http://schemas.openxmlformats.org/officeDocument/2006/relationships/oleObject" Target="../embeddings/oleObject20.bin"/><Relationship Id="rId40" Type="http://schemas.openxmlformats.org/officeDocument/2006/relationships/image" Target="../media/image20.png"/><Relationship Id="rId4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8"/>
          <p:cNvSpPr/>
          <p:nvPr/>
        </p:nvSpPr>
        <p:spPr>
          <a:xfrm>
            <a:off x="1967040" y="932328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Supplementary Figure 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14"/>
          <p:cNvGraphicFramePr/>
          <p:nvPr/>
        </p:nvGraphicFramePr>
        <p:xfrm>
          <a:off x="463680" y="2997360"/>
          <a:ext cx="1079280" cy="1079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1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3680" y="2997360"/>
                    <a:ext cx="107928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Object 15"/>
          <p:cNvGraphicFramePr/>
          <p:nvPr/>
        </p:nvGraphicFramePr>
        <p:xfrm>
          <a:off x="3746520" y="2997360"/>
          <a:ext cx="1079640" cy="1079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Object 1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746520" y="2997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Object 7"/>
          <p:cNvGraphicFramePr/>
          <p:nvPr/>
        </p:nvGraphicFramePr>
        <p:xfrm>
          <a:off x="1558800" y="2997360"/>
          <a:ext cx="1079640" cy="10792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7" name="Object 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558800" y="2997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Object 8"/>
          <p:cNvGraphicFramePr/>
          <p:nvPr/>
        </p:nvGraphicFramePr>
        <p:xfrm>
          <a:off x="2651040" y="2997360"/>
          <a:ext cx="1079640" cy="10792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9" name="Object 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651040" y="2997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9"/>
          <p:cNvGraphicFramePr/>
          <p:nvPr/>
        </p:nvGraphicFramePr>
        <p:xfrm>
          <a:off x="4840200" y="2997360"/>
          <a:ext cx="1079640" cy="10792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1" name="Object 9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840200" y="2997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28"/>
          <p:cNvGraphicFramePr/>
          <p:nvPr/>
        </p:nvGraphicFramePr>
        <p:xfrm>
          <a:off x="463680" y="4086360"/>
          <a:ext cx="1079280" cy="10792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3" name="Object 28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63680" y="4086360"/>
                    <a:ext cx="107928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Object 29"/>
          <p:cNvGraphicFramePr/>
          <p:nvPr/>
        </p:nvGraphicFramePr>
        <p:xfrm>
          <a:off x="3746520" y="4086360"/>
          <a:ext cx="1079640" cy="107928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55" name="Object 29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746520" y="4086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30"/>
          <p:cNvGraphicFramePr/>
          <p:nvPr/>
        </p:nvGraphicFramePr>
        <p:xfrm>
          <a:off x="2651040" y="4086360"/>
          <a:ext cx="1079640" cy="107928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57" name="Object 30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651040" y="4086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Object 31"/>
          <p:cNvGraphicFramePr/>
          <p:nvPr/>
        </p:nvGraphicFramePr>
        <p:xfrm>
          <a:off x="1558800" y="4086360"/>
          <a:ext cx="1079640" cy="107928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59" name="Object 31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1558800" y="4086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Object 32"/>
          <p:cNvGraphicFramePr/>
          <p:nvPr/>
        </p:nvGraphicFramePr>
        <p:xfrm>
          <a:off x="4840200" y="4086360"/>
          <a:ext cx="1079640" cy="10792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61" name="Object 32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840200" y="4086360"/>
                    <a:ext cx="1079640" cy="10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62" name="Group 69"/>
          <p:cNvGrpSpPr/>
          <p:nvPr/>
        </p:nvGrpSpPr>
        <p:grpSpPr>
          <a:xfrm>
            <a:off x="266760" y="883800"/>
            <a:ext cx="231120" cy="1516320"/>
            <a:chOff x="266760" y="883800"/>
            <a:chExt cx="231120" cy="1516320"/>
          </a:xfrm>
        </p:grpSpPr>
        <p:sp>
          <p:nvSpPr>
            <p:cNvPr id="63" name="Text Box 33"/>
            <p:cNvSpPr/>
            <p:nvPr/>
          </p:nvSpPr>
          <p:spPr>
            <a:xfrm rot="16200000">
              <a:off x="163800" y="98640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33"/>
            <p:cNvSpPr/>
            <p:nvPr/>
          </p:nvSpPr>
          <p:spPr>
            <a:xfrm rot="16200000">
              <a:off x="101520" y="2003760"/>
              <a:ext cx="561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Shield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Group 58"/>
          <p:cNvGrpSpPr/>
          <p:nvPr/>
        </p:nvGrpSpPr>
        <p:grpSpPr>
          <a:xfrm>
            <a:off x="702360" y="361800"/>
            <a:ext cx="5104800" cy="217440"/>
            <a:chOff x="702360" y="361800"/>
            <a:chExt cx="5104800" cy="217440"/>
          </a:xfrm>
        </p:grpSpPr>
        <p:sp>
          <p:nvSpPr>
            <p:cNvPr id="66" name="Rectangle 135"/>
            <p:cNvSpPr/>
            <p:nvPr/>
          </p:nvSpPr>
          <p:spPr>
            <a:xfrm>
              <a:off x="702360" y="363600"/>
              <a:ext cx="48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h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36"/>
            <p:cNvSpPr/>
            <p:nvPr/>
          </p:nvSpPr>
          <p:spPr>
            <a:xfrm>
              <a:off x="1796040" y="363600"/>
              <a:ext cx="57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dFYV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137"/>
            <p:cNvSpPr/>
            <p:nvPr/>
          </p:nvSpPr>
          <p:spPr>
            <a:xfrm>
              <a:off x="2678040" y="361800"/>
              <a:ext cx="312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      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NR                             FtsH1                            Mer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69" name="Object 138"/>
          <p:cNvGraphicFramePr/>
          <p:nvPr/>
        </p:nvGraphicFramePr>
        <p:xfrm>
          <a:off x="463680" y="531720"/>
          <a:ext cx="1079280" cy="107964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70" name="Object 138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463680" y="531720"/>
                    <a:ext cx="107928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1" name="Object 139"/>
          <p:cNvGraphicFramePr/>
          <p:nvPr/>
        </p:nvGraphicFramePr>
        <p:xfrm>
          <a:off x="1558800" y="531720"/>
          <a:ext cx="1079640" cy="107964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72" name="Object 139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558800" y="531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3" name="Object 140"/>
          <p:cNvGraphicFramePr/>
          <p:nvPr/>
        </p:nvGraphicFramePr>
        <p:xfrm>
          <a:off x="3746520" y="531720"/>
          <a:ext cx="1079640" cy="107964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74" name="Object 140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3746520" y="531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5" name="Object 141"/>
          <p:cNvGraphicFramePr/>
          <p:nvPr/>
        </p:nvGraphicFramePr>
        <p:xfrm>
          <a:off x="2651040" y="531720"/>
          <a:ext cx="1079640" cy="107964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76" name="Object 141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2651040" y="531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7" name="Object 142"/>
          <p:cNvGraphicFramePr/>
          <p:nvPr/>
        </p:nvGraphicFramePr>
        <p:xfrm>
          <a:off x="4840200" y="531720"/>
          <a:ext cx="1079640" cy="107964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78" name="Object 142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4840200" y="531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Object 37"/>
          <p:cNvGraphicFramePr/>
          <p:nvPr/>
        </p:nvGraphicFramePr>
        <p:xfrm>
          <a:off x="463680" y="1620720"/>
          <a:ext cx="1079280" cy="107964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80" name="Object 37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463680" y="1620720"/>
                    <a:ext cx="107928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1" name="Object 38"/>
          <p:cNvGraphicFramePr/>
          <p:nvPr/>
        </p:nvGraphicFramePr>
        <p:xfrm>
          <a:off x="1558800" y="1620720"/>
          <a:ext cx="1079640" cy="107964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82" name="Object 38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1558800" y="1620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3" name="Object 39"/>
          <p:cNvGraphicFramePr/>
          <p:nvPr/>
        </p:nvGraphicFramePr>
        <p:xfrm>
          <a:off x="2651040" y="1620720"/>
          <a:ext cx="1079640" cy="107964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84" name="Object 39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2651040" y="1620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5" name="Object 40"/>
          <p:cNvGraphicFramePr/>
          <p:nvPr/>
        </p:nvGraphicFramePr>
        <p:xfrm>
          <a:off x="3746520" y="1620720"/>
          <a:ext cx="1079640" cy="1079640"/>
        </p:xfrm>
        <a:graphic>
          <a:graphicData uri="http://schemas.openxmlformats.org/presentationml/2006/ole">
            <p:oleObj r:id="rId37" spid="">
              <p:embed/>
              <p:pic>
                <p:nvPicPr>
                  <p:cNvPr id="86" name="Object 40" descr=""/>
                  <p:cNvPicPr/>
                  <p:nvPr/>
                </p:nvPicPr>
                <p:blipFill>
                  <a:blip r:embed="rId38"/>
                  <a:stretch/>
                </p:blipFill>
                <p:spPr>
                  <a:xfrm>
                    <a:off x="3746520" y="1620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7" name="Object 41"/>
          <p:cNvGraphicFramePr/>
          <p:nvPr/>
        </p:nvGraphicFramePr>
        <p:xfrm>
          <a:off x="4840200" y="1620720"/>
          <a:ext cx="1079640" cy="1079640"/>
        </p:xfrm>
        <a:graphic>
          <a:graphicData uri="http://schemas.openxmlformats.org/presentationml/2006/ole">
            <p:oleObj r:id="rId39" spid="">
              <p:embed/>
              <p:pic>
                <p:nvPicPr>
                  <p:cNvPr id="88" name="Object 41" descr=""/>
                  <p:cNvPicPr/>
                  <p:nvPr/>
                </p:nvPicPr>
                <p:blipFill>
                  <a:blip r:embed="rId40"/>
                  <a:stretch/>
                </p:blipFill>
                <p:spPr>
                  <a:xfrm>
                    <a:off x="4840200" y="1620720"/>
                    <a:ext cx="1079640" cy="10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89" name="Group 57"/>
          <p:cNvGrpSpPr/>
          <p:nvPr/>
        </p:nvGrpSpPr>
        <p:grpSpPr>
          <a:xfrm>
            <a:off x="702360" y="2816280"/>
            <a:ext cx="5104800" cy="217440"/>
            <a:chOff x="702360" y="2816280"/>
            <a:chExt cx="5104800" cy="217440"/>
          </a:xfrm>
        </p:grpSpPr>
        <p:sp>
          <p:nvSpPr>
            <p:cNvPr id="90" name="Rectangle 135"/>
            <p:cNvSpPr/>
            <p:nvPr/>
          </p:nvSpPr>
          <p:spPr>
            <a:xfrm>
              <a:off x="702360" y="2818080"/>
              <a:ext cx="48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h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36"/>
            <p:cNvSpPr/>
            <p:nvPr/>
          </p:nvSpPr>
          <p:spPr>
            <a:xfrm>
              <a:off x="1795680" y="2818080"/>
              <a:ext cx="57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dFYV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37"/>
            <p:cNvSpPr/>
            <p:nvPr/>
          </p:nvSpPr>
          <p:spPr>
            <a:xfrm>
              <a:off x="2678040" y="2816280"/>
              <a:ext cx="312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      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NR                               APT1                            Mer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Group 65"/>
          <p:cNvGrpSpPr/>
          <p:nvPr/>
        </p:nvGrpSpPr>
        <p:grpSpPr>
          <a:xfrm>
            <a:off x="266760" y="3347640"/>
            <a:ext cx="231120" cy="1629360"/>
            <a:chOff x="266760" y="3347640"/>
            <a:chExt cx="231120" cy="1629360"/>
          </a:xfrm>
        </p:grpSpPr>
        <p:sp>
          <p:nvSpPr>
            <p:cNvPr id="94" name="Text Box 33"/>
            <p:cNvSpPr/>
            <p:nvPr/>
          </p:nvSpPr>
          <p:spPr>
            <a:xfrm rot="16200000">
              <a:off x="163800" y="34502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33"/>
            <p:cNvSpPr/>
            <p:nvPr/>
          </p:nvSpPr>
          <p:spPr>
            <a:xfrm rot="16200000">
              <a:off x="-12600" y="4466160"/>
              <a:ext cx="790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Shield-1  24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11:44:30Z</dcterms:created>
  <dc:creator>kai</dc:creator>
  <dc:description/>
  <dc:language>en-US</dc:language>
  <cp:lastModifiedBy>Maryse</cp:lastModifiedBy>
  <dcterms:modified xsi:type="dcterms:W3CDTF">2010-12-16T20:18:49Z</dcterms:modified>
  <cp:revision>143</cp:revision>
  <dc:subject/>
  <dc:title>Diapositive 1</dc:title>
</cp:coreProperties>
</file>